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 bookmarkIdSeed="24">
  <p:sldMasterIdLst>
    <p:sldMasterId id="2147483840" r:id="rId1"/>
  </p:sldMasterIdLst>
  <p:notesMasterIdLst>
    <p:notesMasterId r:id="rId3"/>
  </p:notesMasterIdLst>
  <p:sldIdLst>
    <p:sldId id="287" r:id="rId2"/>
  </p:sldIdLst>
  <p:sldSz cx="73152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1CD8B72-5FF1-4F32-8C2C-D7B4478E4F1D}">
          <p14:sldIdLst>
            <p14:sldId id="28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7FB36E-97C1-D6CC-FC60-8D30DA5DA027}" name="Arik Davidyan" initials="AD" userId="S::davidyana@omrf.org::8ca9df27-1e11-474e-a10a-be4812d5a88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30" autoAdjust="0"/>
    <p:restoredTop sz="93645" autoAdjust="0"/>
  </p:normalViewPr>
  <p:slideViewPr>
    <p:cSldViewPr snapToGrid="0">
      <p:cViewPr varScale="1">
        <p:scale>
          <a:sx n="111" d="100"/>
          <a:sy n="111" d="100"/>
        </p:scale>
        <p:origin x="439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A46E605-F6B1-403E-A899-FABDB04BC04A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3788" y="1162050"/>
            <a:ext cx="22828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4F2219B-4F43-4EA6-982C-2FB4872F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40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332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3429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88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719311A-ACB0-1F7B-D2CB-EC637A3F6E17}"/>
              </a:ext>
            </a:extLst>
          </p:cNvPr>
          <p:cNvCxnSpPr/>
          <p:nvPr userDrawn="1"/>
        </p:nvCxnSpPr>
        <p:spPr>
          <a:xfrm>
            <a:off x="870948" y="1477978"/>
            <a:ext cx="576451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492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80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673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86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649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70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813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3108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4732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0BB09F-CC97-19F8-AEEE-14E29BE01A68}"/>
              </a:ext>
            </a:extLst>
          </p:cNvPr>
          <p:cNvSpPr txBox="1"/>
          <p:nvPr/>
        </p:nvSpPr>
        <p:spPr>
          <a:xfrm>
            <a:off x="0" y="5026890"/>
            <a:ext cx="71323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igure 2: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Liver mas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riglyceride content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Westerns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ranscription of the gluconeogenic enzymes. Gene expression of live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PEPCK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6Pase. Determination of the fractional synthesis rates in th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itochondrial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xed fractions of liver. </a:t>
            </a:r>
            <a:r>
              <a:rPr lang="en-US" sz="1200" dirty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Data were analyzed by two-way ANOVA (group x treatment) and are represented as mean ± SEM from 6-7 rats per group.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36DA5BE-E2A9-2DF9-44D4-06A3299B7B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0694573"/>
              </p:ext>
            </p:extLst>
          </p:nvPr>
        </p:nvGraphicFramePr>
        <p:xfrm>
          <a:off x="6419461" y="306237"/>
          <a:ext cx="895739" cy="438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907279" imgH="932882" progId="Prism9.Document">
                  <p:embed/>
                </p:oleObj>
              </mc:Choice>
              <mc:Fallback>
                <p:oleObj name="Prism 9" r:id="rId2" imgW="1907279" imgH="932882" progId="Prism9.Document">
                  <p:embed/>
                  <p:pic>
                    <p:nvPicPr>
                      <p:cNvPr id="55" name="Object 54">
                        <a:extLst>
                          <a:ext uri="{FF2B5EF4-FFF2-40B4-BE49-F238E27FC236}">
                            <a16:creationId xmlns:a16="http://schemas.microsoft.com/office/drawing/2014/main" id="{27BA69DA-6C9B-1428-60F8-9C2552FF6A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19461" y="306237"/>
                        <a:ext cx="895739" cy="438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6" name="Picture 25">
            <a:extLst>
              <a:ext uri="{FF2B5EF4-FFF2-40B4-BE49-F238E27FC236}">
                <a16:creationId xmlns:a16="http://schemas.microsoft.com/office/drawing/2014/main" id="{E4BE874B-5E06-32BE-D011-682E46856E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561"/>
          <a:stretch/>
        </p:blipFill>
        <p:spPr>
          <a:xfrm>
            <a:off x="431217" y="3953761"/>
            <a:ext cx="2912196" cy="90864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111C963-2337-D431-A4AB-E60C9E4370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7265" y="3960581"/>
            <a:ext cx="2912196" cy="895008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685FF2E-0C4A-0A0E-1424-EDD89F6C34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1065509"/>
              </p:ext>
            </p:extLst>
          </p:nvPr>
        </p:nvGraphicFramePr>
        <p:xfrm>
          <a:off x="0" y="0"/>
          <a:ext cx="6897192" cy="39537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9064976" imgH="5195840" progId="Prism10.Document">
                  <p:embed/>
                </p:oleObj>
              </mc:Choice>
              <mc:Fallback>
                <p:oleObj name="Prism 10" r:id="rId6" imgW="9064976" imgH="519584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6897192" cy="39537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96794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402</TotalTime>
  <Words>8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1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formin treatment effects on protein turnover in the HCR/LCR rat model</dc:title>
  <dc:creator>Matt Bubak</dc:creator>
  <cp:lastModifiedBy>Matthew Bubak</cp:lastModifiedBy>
  <cp:revision>319</cp:revision>
  <cp:lastPrinted>2023-12-15T16:29:23Z</cp:lastPrinted>
  <dcterms:created xsi:type="dcterms:W3CDTF">2022-07-14T20:18:29Z</dcterms:created>
  <dcterms:modified xsi:type="dcterms:W3CDTF">2024-03-01T16:37:42Z</dcterms:modified>
</cp:coreProperties>
</file>